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23" r:id="rId2"/>
    <p:sldId id="336" r:id="rId3"/>
    <p:sldId id="337" r:id="rId4"/>
    <p:sldId id="324" r:id="rId5"/>
    <p:sldId id="318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Robert Chemelewski" initials="RC" lastIdx="1" clrIdx="0">
    <p:extLst>
      <p:ext uri="{19B8F6BF-5375-455C-9EA6-DF929625EA0E}">
        <p15:presenceInfo xmlns:p15="http://schemas.microsoft.com/office/powerpoint/2012/main" userId="e8a550d334cd12dc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77" d="100"/>
          <a:sy n="77" d="100"/>
        </p:scale>
        <p:origin x="26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9A0097-5800-AB37-37C1-7A193ABEF99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87A1522-ECB2-AB1B-4719-41C68B64230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10EEEC-852D-86EE-E0B4-8EDD0C82AC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911AA-B51F-427C-BEF0-2610E0E6B108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B3F7D8-5864-4E51-BE08-03C56C2DBC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8D0165-241F-F934-6695-5EC66264E0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C39C0-C3A9-4DCC-A7A0-CA49B10353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03336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643EC5-A59F-0866-312D-AE200F04E8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8AAE128-2ABE-69F9-455F-298B36C8504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4438A3-631D-A3A1-A742-BE479AE5E1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911AA-B51F-427C-BEF0-2610E0E6B108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CF3D18-0616-64A1-22F3-CD69371FFF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628931-C5A0-4DB5-F717-A1B7FF08E9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C39C0-C3A9-4DCC-A7A0-CA49B10353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72263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3BC91D0-DAB5-3556-B6A2-0ADE6E7A416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8649C1F-4B7A-7D97-68F1-92FE7A9634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DEC7E26-3F51-4D73-E973-B9508A0E8D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911AA-B51F-427C-BEF0-2610E0E6B108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184EAF-FD32-62F6-B082-4CEF0B67B2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522BA8-487B-1825-C10D-BCFBAD33C8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C39C0-C3A9-4DCC-A7A0-CA49B10353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74293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429981-C582-B30D-EDE9-6B430B7A1E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195D94-9E4E-03B5-393C-97CD62FC7E9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31C74F-ACD8-3850-330E-9E98AD70E7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911AA-B51F-427C-BEF0-2610E0E6B108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B33387-0AF5-A511-A33E-264B294334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E61FD8-A21D-02D9-E0E5-21B0FB0EA1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C39C0-C3A9-4DCC-A7A0-CA49B10353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91327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873963-37AA-71B3-7EBF-32462D1CCC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568C44E-A601-6DF5-FC3E-BB2959A012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90A5CC-F4F3-37A7-EF92-55C4B4E702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911AA-B51F-427C-BEF0-2610E0E6B108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A3371F-4703-01B9-D6E5-C4C9015635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E127EF-88A6-0394-FA8B-992E48F68D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C39C0-C3A9-4DCC-A7A0-CA49B10353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48765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0FFF8F-5E5D-11C0-A4BD-E23F517FD9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441D02B-629C-B895-0623-3ECF856EF12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E7A3C41-7877-366F-D221-5BB8EFFB36E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2A941D4-C72A-1811-23B9-626B248492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911AA-B51F-427C-BEF0-2610E0E6B108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34A09CD-5039-D5F9-3B29-261C6328DC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60EC745-DCF2-69B3-4DBA-C5DE039D66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C39C0-C3A9-4DCC-A7A0-CA49B10353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83764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BE69C2-7AF2-AB10-2AB8-46D0EA924A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1C03C01-F7A1-6672-CE9F-FE3D5F2080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38BD65A-E212-BA28-0511-D036D90EEAE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B0BF4D3-BB4D-02C7-A91C-C1B5F11A8D4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986987F-3AA3-05C5-105C-9DAAA8A9AF1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DC2D4C5-1FDD-42BA-FA84-F4C272C104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911AA-B51F-427C-BEF0-2610E0E6B108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F68F2CB-CAA6-F214-CCEE-6E1DF007A0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19CA7CF-1BDA-600A-9CBA-B7DE681BA0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C39C0-C3A9-4DCC-A7A0-CA49B10353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22245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CE58D3-441E-9371-E1A3-0900367C4E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1DD9C29-2D63-2C70-E358-13AB19E74E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911AA-B51F-427C-BEF0-2610E0E6B108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C107224-AEFF-2019-9AE5-B44BEB5521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4A77B19-57F3-5848-AE40-856035BD44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C39C0-C3A9-4DCC-A7A0-CA49B10353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64942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836466D-6116-F6F9-EE6D-CE32EDD43C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911AA-B51F-427C-BEF0-2610E0E6B108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7137B97-E4B5-20C4-2A78-09E21798F9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6F6B42A-AD18-CABE-E59F-06A0101B74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C39C0-C3A9-4DCC-A7A0-CA49B10353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89627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C6A3CB-EF09-8F3E-B80A-E873FFB66B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7B45849-36BD-F2F0-56F5-FF16FDAC8E0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1350153-CAB3-2D12-378A-3BDB648ED1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60E3D73-215B-0A29-6A80-B8778DB1BB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911AA-B51F-427C-BEF0-2610E0E6B108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CEBFCB2-8EAE-F05D-F00E-0DAFE542FA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E9D70BC-AE19-1ABC-6EEF-B590D627F3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C39C0-C3A9-4DCC-A7A0-CA49B10353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57515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663285-3151-F62F-3DAC-347E593EF3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DD0988E-674E-3529-C119-EE57F62FB00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262B05E-07C2-C50F-4085-B0290E73AF0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8D1CFBD-43E5-7FDA-7C3C-EBC7490F37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911AA-B51F-427C-BEF0-2610E0E6B108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0B1FF09-3492-9358-13A1-6E8F611C0D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3C287E0-948A-6A5F-1852-BD840193EF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C39C0-C3A9-4DCC-A7A0-CA49B10353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16642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99D0350-6BBB-0324-E14B-C570583935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F707A77-29E0-00F4-4191-20A8DF42F1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42F6BC-AEBF-710A-671D-931FD00DCAE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4911AA-B51F-427C-BEF0-2610E0E6B108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A4FFEF-0ECB-D3FC-85AA-EF2D0085A02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EFCB79-A4B8-D9C8-93CA-7BA4AC28412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5C39C0-C3A9-4DCC-A7A0-CA49B10353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11699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A3DCE2-362C-545C-1BB3-E0CF6EEAF4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al Table 1: E-20 cut off selection </a:t>
            </a:r>
            <a:r>
              <a:rPr lang="en-US" dirty="0" err="1"/>
              <a:t>critera</a:t>
            </a:r>
            <a:endParaRPr lang="en-US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1EBE09C5-2D2D-86D6-3826-59D33F2C064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45145" y="670560"/>
            <a:ext cx="3339766" cy="61874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801024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AD77F8-2E4C-3884-D477-253D1C4EA1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al Table 2: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A8C1937D-7307-FFB6-49C4-EF99C179A03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47358" y="1087120"/>
            <a:ext cx="4624922" cy="57708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584136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ED4EF4-5537-31C1-12C9-296E51222E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al Table 3:</a:t>
            </a:r>
          </a:p>
        </p:txBody>
      </p:sp>
      <p:pic>
        <p:nvPicPr>
          <p:cNvPr id="7" name="Content Placeholder 6">
            <a:extLst>
              <a:ext uri="{FF2B5EF4-FFF2-40B4-BE49-F238E27FC236}">
                <a16:creationId xmlns:a16="http://schemas.microsoft.com/office/drawing/2014/main" id="{97055D3A-0462-B78D-08FE-AD3AF48B81A0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3356022" y="1825625"/>
            <a:ext cx="5479955" cy="43513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804838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965EA8-EF0C-D014-F74A-F1893CB7E3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3094608" cy="2937368"/>
          </a:xfrm>
        </p:spPr>
        <p:txBody>
          <a:bodyPr/>
          <a:lstStyle/>
          <a:p>
            <a:r>
              <a:rPr lang="en-US" dirty="0"/>
              <a:t>Supplemental Table 4: GRN .95 cut off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94960522-D71B-F2C0-EF25-7B9A67D971F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88059" y="0"/>
            <a:ext cx="2815881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9360529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DF166C-4514-631C-1AE4-FB828ABEB9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al </a:t>
            </a:r>
            <a:br>
              <a:rPr lang="en-US" dirty="0"/>
            </a:br>
            <a:r>
              <a:rPr lang="en-US" dirty="0"/>
              <a:t>Table 5: GRN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E087F0E9-12DC-A501-752E-976F81E00688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4267547" y="0"/>
            <a:ext cx="5107362" cy="67984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893247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32</Words>
  <Application>Microsoft Office PowerPoint</Application>
  <PresentationFormat>Widescreen</PresentationFormat>
  <Paragraphs>5</Paragraphs>
  <Slides>5</Slides>
  <Notes>0</Notes>
  <HiddenSlides>1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Supplemental Table 1: E-20 cut off selection critera</vt:lpstr>
      <vt:lpstr>Supplemental Table 2:</vt:lpstr>
      <vt:lpstr>Supplemental Table 3:</vt:lpstr>
      <vt:lpstr>Supplemental Table 4: GRN .95 cut off</vt:lpstr>
      <vt:lpstr>Supplemental  Table 5: GR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bert Chemelewski</dc:creator>
  <cp:lastModifiedBy>Abby Rassette</cp:lastModifiedBy>
  <cp:revision>7</cp:revision>
  <dcterms:created xsi:type="dcterms:W3CDTF">2023-05-23T18:35:33Z</dcterms:created>
  <dcterms:modified xsi:type="dcterms:W3CDTF">2023-09-11T14:24:33Z</dcterms:modified>
</cp:coreProperties>
</file>